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11155363" cy="61261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5" autoAdjust="0"/>
    <p:restoredTop sz="94660"/>
  </p:normalViewPr>
  <p:slideViewPr>
    <p:cSldViewPr snapToGrid="0">
      <p:cViewPr varScale="1">
        <p:scale>
          <a:sx n="92" d="100"/>
          <a:sy n="92" d="100"/>
        </p:scale>
        <p:origin x="76" y="7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94421" y="1002593"/>
            <a:ext cx="8366522" cy="2132812"/>
          </a:xfrm>
        </p:spPr>
        <p:txBody>
          <a:bodyPr anchor="b"/>
          <a:lstStyle>
            <a:lvl1pPr algn="ctr">
              <a:defRPr sz="5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94421" y="3217654"/>
            <a:ext cx="8366522" cy="1479071"/>
          </a:xfrm>
        </p:spPr>
        <p:txBody>
          <a:bodyPr/>
          <a:lstStyle>
            <a:lvl1pPr marL="0" indent="0" algn="ctr">
              <a:buNone/>
              <a:defRPr sz="2144"/>
            </a:lvl1pPr>
            <a:lvl2pPr marL="408417" indent="0" algn="ctr">
              <a:buNone/>
              <a:defRPr sz="1787"/>
            </a:lvl2pPr>
            <a:lvl3pPr marL="816834" indent="0" algn="ctr">
              <a:buNone/>
              <a:defRPr sz="1608"/>
            </a:lvl3pPr>
            <a:lvl4pPr marL="1225250" indent="0" algn="ctr">
              <a:buNone/>
              <a:defRPr sz="1429"/>
            </a:lvl4pPr>
            <a:lvl5pPr marL="1633667" indent="0" algn="ctr">
              <a:buNone/>
              <a:defRPr sz="1429"/>
            </a:lvl5pPr>
            <a:lvl6pPr marL="2042084" indent="0" algn="ctr">
              <a:buNone/>
              <a:defRPr sz="1429"/>
            </a:lvl6pPr>
            <a:lvl7pPr marL="2450501" indent="0" algn="ctr">
              <a:buNone/>
              <a:defRPr sz="1429"/>
            </a:lvl7pPr>
            <a:lvl8pPr marL="2858917" indent="0" algn="ctr">
              <a:buNone/>
              <a:defRPr sz="1429"/>
            </a:lvl8pPr>
            <a:lvl9pPr marL="3267334" indent="0" algn="ctr">
              <a:buNone/>
              <a:defRPr sz="1429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838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12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83057" y="326161"/>
            <a:ext cx="2405375" cy="519164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66931" y="326161"/>
            <a:ext cx="7076683" cy="519164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364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520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1121" y="1527287"/>
            <a:ext cx="9621501" cy="2548313"/>
          </a:xfrm>
        </p:spPr>
        <p:txBody>
          <a:bodyPr anchor="b"/>
          <a:lstStyle>
            <a:lvl1pPr>
              <a:defRPr sz="53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1121" y="4099708"/>
            <a:ext cx="9621501" cy="1340098"/>
          </a:xfrm>
        </p:spPr>
        <p:txBody>
          <a:bodyPr/>
          <a:lstStyle>
            <a:lvl1pPr marL="0" indent="0">
              <a:buNone/>
              <a:defRPr sz="2144">
                <a:solidFill>
                  <a:schemeClr val="tx1">
                    <a:tint val="75000"/>
                  </a:schemeClr>
                </a:solidFill>
              </a:defRPr>
            </a:lvl1pPr>
            <a:lvl2pPr marL="408417" indent="0">
              <a:buNone/>
              <a:defRPr sz="1787">
                <a:solidFill>
                  <a:schemeClr val="tx1">
                    <a:tint val="75000"/>
                  </a:schemeClr>
                </a:solidFill>
              </a:defRPr>
            </a:lvl2pPr>
            <a:lvl3pPr marL="816834" indent="0">
              <a:buNone/>
              <a:defRPr sz="1608">
                <a:solidFill>
                  <a:schemeClr val="tx1">
                    <a:tint val="75000"/>
                  </a:schemeClr>
                </a:solidFill>
              </a:defRPr>
            </a:lvl3pPr>
            <a:lvl4pPr marL="1225250" indent="0">
              <a:buNone/>
              <a:defRPr sz="1429">
                <a:solidFill>
                  <a:schemeClr val="tx1">
                    <a:tint val="75000"/>
                  </a:schemeClr>
                </a:solidFill>
              </a:defRPr>
            </a:lvl4pPr>
            <a:lvl5pPr marL="1633667" indent="0">
              <a:buNone/>
              <a:defRPr sz="1429">
                <a:solidFill>
                  <a:schemeClr val="tx1">
                    <a:tint val="75000"/>
                  </a:schemeClr>
                </a:solidFill>
              </a:defRPr>
            </a:lvl5pPr>
            <a:lvl6pPr marL="2042084" indent="0">
              <a:buNone/>
              <a:defRPr sz="1429">
                <a:solidFill>
                  <a:schemeClr val="tx1">
                    <a:tint val="75000"/>
                  </a:schemeClr>
                </a:solidFill>
              </a:defRPr>
            </a:lvl6pPr>
            <a:lvl7pPr marL="2450501" indent="0">
              <a:buNone/>
              <a:defRPr sz="1429">
                <a:solidFill>
                  <a:schemeClr val="tx1">
                    <a:tint val="75000"/>
                  </a:schemeClr>
                </a:solidFill>
              </a:defRPr>
            </a:lvl7pPr>
            <a:lvl8pPr marL="2858917" indent="0">
              <a:buNone/>
              <a:defRPr sz="1429">
                <a:solidFill>
                  <a:schemeClr val="tx1">
                    <a:tint val="75000"/>
                  </a:schemeClr>
                </a:solidFill>
              </a:defRPr>
            </a:lvl8pPr>
            <a:lvl9pPr marL="3267334" indent="0">
              <a:buNone/>
              <a:defRPr sz="142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754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66931" y="1630807"/>
            <a:ext cx="4741029" cy="388699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47403" y="1630807"/>
            <a:ext cx="4741029" cy="388699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381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384" y="326162"/>
            <a:ext cx="9621501" cy="118410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8385" y="1501761"/>
            <a:ext cx="4719241" cy="735990"/>
          </a:xfrm>
        </p:spPr>
        <p:txBody>
          <a:bodyPr anchor="b"/>
          <a:lstStyle>
            <a:lvl1pPr marL="0" indent="0">
              <a:buNone/>
              <a:defRPr sz="2144" b="1"/>
            </a:lvl1pPr>
            <a:lvl2pPr marL="408417" indent="0">
              <a:buNone/>
              <a:defRPr sz="1787" b="1"/>
            </a:lvl2pPr>
            <a:lvl3pPr marL="816834" indent="0">
              <a:buNone/>
              <a:defRPr sz="1608" b="1"/>
            </a:lvl3pPr>
            <a:lvl4pPr marL="1225250" indent="0">
              <a:buNone/>
              <a:defRPr sz="1429" b="1"/>
            </a:lvl4pPr>
            <a:lvl5pPr marL="1633667" indent="0">
              <a:buNone/>
              <a:defRPr sz="1429" b="1"/>
            </a:lvl5pPr>
            <a:lvl6pPr marL="2042084" indent="0">
              <a:buNone/>
              <a:defRPr sz="1429" b="1"/>
            </a:lvl6pPr>
            <a:lvl7pPr marL="2450501" indent="0">
              <a:buNone/>
              <a:defRPr sz="1429" b="1"/>
            </a:lvl7pPr>
            <a:lvl8pPr marL="2858917" indent="0">
              <a:buNone/>
              <a:defRPr sz="1429" b="1"/>
            </a:lvl8pPr>
            <a:lvl9pPr marL="3267334" indent="0">
              <a:buNone/>
              <a:defRPr sz="1429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8385" y="2237751"/>
            <a:ext cx="4719241" cy="329139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47403" y="1501761"/>
            <a:ext cx="4742482" cy="735990"/>
          </a:xfrm>
        </p:spPr>
        <p:txBody>
          <a:bodyPr anchor="b"/>
          <a:lstStyle>
            <a:lvl1pPr marL="0" indent="0">
              <a:buNone/>
              <a:defRPr sz="2144" b="1"/>
            </a:lvl1pPr>
            <a:lvl2pPr marL="408417" indent="0">
              <a:buNone/>
              <a:defRPr sz="1787" b="1"/>
            </a:lvl2pPr>
            <a:lvl3pPr marL="816834" indent="0">
              <a:buNone/>
              <a:defRPr sz="1608" b="1"/>
            </a:lvl3pPr>
            <a:lvl4pPr marL="1225250" indent="0">
              <a:buNone/>
              <a:defRPr sz="1429" b="1"/>
            </a:lvl4pPr>
            <a:lvl5pPr marL="1633667" indent="0">
              <a:buNone/>
              <a:defRPr sz="1429" b="1"/>
            </a:lvl5pPr>
            <a:lvl6pPr marL="2042084" indent="0">
              <a:buNone/>
              <a:defRPr sz="1429" b="1"/>
            </a:lvl6pPr>
            <a:lvl7pPr marL="2450501" indent="0">
              <a:buNone/>
              <a:defRPr sz="1429" b="1"/>
            </a:lvl7pPr>
            <a:lvl8pPr marL="2858917" indent="0">
              <a:buNone/>
              <a:defRPr sz="1429" b="1"/>
            </a:lvl8pPr>
            <a:lvl9pPr marL="3267334" indent="0">
              <a:buNone/>
              <a:defRPr sz="1429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47403" y="2237751"/>
            <a:ext cx="4742482" cy="329139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178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369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952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384" y="408411"/>
            <a:ext cx="3597895" cy="1429438"/>
          </a:xfrm>
        </p:spPr>
        <p:txBody>
          <a:bodyPr anchor="b"/>
          <a:lstStyle>
            <a:lvl1pPr>
              <a:defRPr sz="285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42482" y="882055"/>
            <a:ext cx="5647403" cy="4353546"/>
          </a:xfrm>
        </p:spPr>
        <p:txBody>
          <a:bodyPr/>
          <a:lstStyle>
            <a:lvl1pPr>
              <a:defRPr sz="2859"/>
            </a:lvl1pPr>
            <a:lvl2pPr>
              <a:defRPr sz="2501"/>
            </a:lvl2pPr>
            <a:lvl3pPr>
              <a:defRPr sz="2144"/>
            </a:lvl3pPr>
            <a:lvl4pPr>
              <a:defRPr sz="1787"/>
            </a:lvl4pPr>
            <a:lvl5pPr>
              <a:defRPr sz="1787"/>
            </a:lvl5pPr>
            <a:lvl6pPr>
              <a:defRPr sz="1787"/>
            </a:lvl6pPr>
            <a:lvl7pPr>
              <a:defRPr sz="1787"/>
            </a:lvl7pPr>
            <a:lvl8pPr>
              <a:defRPr sz="1787"/>
            </a:lvl8pPr>
            <a:lvl9pPr>
              <a:defRPr sz="178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8384" y="1837849"/>
            <a:ext cx="3597895" cy="3404842"/>
          </a:xfrm>
        </p:spPr>
        <p:txBody>
          <a:bodyPr/>
          <a:lstStyle>
            <a:lvl1pPr marL="0" indent="0">
              <a:buNone/>
              <a:defRPr sz="1429"/>
            </a:lvl1pPr>
            <a:lvl2pPr marL="408417" indent="0">
              <a:buNone/>
              <a:defRPr sz="1251"/>
            </a:lvl2pPr>
            <a:lvl3pPr marL="816834" indent="0">
              <a:buNone/>
              <a:defRPr sz="1072"/>
            </a:lvl3pPr>
            <a:lvl4pPr marL="1225250" indent="0">
              <a:buNone/>
              <a:defRPr sz="893"/>
            </a:lvl4pPr>
            <a:lvl5pPr marL="1633667" indent="0">
              <a:buNone/>
              <a:defRPr sz="893"/>
            </a:lvl5pPr>
            <a:lvl6pPr marL="2042084" indent="0">
              <a:buNone/>
              <a:defRPr sz="893"/>
            </a:lvl6pPr>
            <a:lvl7pPr marL="2450501" indent="0">
              <a:buNone/>
              <a:defRPr sz="893"/>
            </a:lvl7pPr>
            <a:lvl8pPr marL="2858917" indent="0">
              <a:buNone/>
              <a:defRPr sz="893"/>
            </a:lvl8pPr>
            <a:lvl9pPr marL="3267334" indent="0">
              <a:buNone/>
              <a:defRPr sz="89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31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8384" y="408411"/>
            <a:ext cx="3597895" cy="1429438"/>
          </a:xfrm>
        </p:spPr>
        <p:txBody>
          <a:bodyPr anchor="b"/>
          <a:lstStyle>
            <a:lvl1pPr>
              <a:defRPr sz="285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742482" y="882055"/>
            <a:ext cx="5647403" cy="4353546"/>
          </a:xfrm>
        </p:spPr>
        <p:txBody>
          <a:bodyPr anchor="t"/>
          <a:lstStyle>
            <a:lvl1pPr marL="0" indent="0">
              <a:buNone/>
              <a:defRPr sz="2859"/>
            </a:lvl1pPr>
            <a:lvl2pPr marL="408417" indent="0">
              <a:buNone/>
              <a:defRPr sz="2501"/>
            </a:lvl2pPr>
            <a:lvl3pPr marL="816834" indent="0">
              <a:buNone/>
              <a:defRPr sz="2144"/>
            </a:lvl3pPr>
            <a:lvl4pPr marL="1225250" indent="0">
              <a:buNone/>
              <a:defRPr sz="1787"/>
            </a:lvl4pPr>
            <a:lvl5pPr marL="1633667" indent="0">
              <a:buNone/>
              <a:defRPr sz="1787"/>
            </a:lvl5pPr>
            <a:lvl6pPr marL="2042084" indent="0">
              <a:buNone/>
              <a:defRPr sz="1787"/>
            </a:lvl6pPr>
            <a:lvl7pPr marL="2450501" indent="0">
              <a:buNone/>
              <a:defRPr sz="1787"/>
            </a:lvl7pPr>
            <a:lvl8pPr marL="2858917" indent="0">
              <a:buNone/>
              <a:defRPr sz="1787"/>
            </a:lvl8pPr>
            <a:lvl9pPr marL="3267334" indent="0">
              <a:buNone/>
              <a:defRPr sz="178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8384" y="1837849"/>
            <a:ext cx="3597895" cy="3404842"/>
          </a:xfrm>
        </p:spPr>
        <p:txBody>
          <a:bodyPr/>
          <a:lstStyle>
            <a:lvl1pPr marL="0" indent="0">
              <a:buNone/>
              <a:defRPr sz="1429"/>
            </a:lvl1pPr>
            <a:lvl2pPr marL="408417" indent="0">
              <a:buNone/>
              <a:defRPr sz="1251"/>
            </a:lvl2pPr>
            <a:lvl3pPr marL="816834" indent="0">
              <a:buNone/>
              <a:defRPr sz="1072"/>
            </a:lvl3pPr>
            <a:lvl4pPr marL="1225250" indent="0">
              <a:buNone/>
              <a:defRPr sz="893"/>
            </a:lvl4pPr>
            <a:lvl5pPr marL="1633667" indent="0">
              <a:buNone/>
              <a:defRPr sz="893"/>
            </a:lvl5pPr>
            <a:lvl6pPr marL="2042084" indent="0">
              <a:buNone/>
              <a:defRPr sz="893"/>
            </a:lvl6pPr>
            <a:lvl7pPr marL="2450501" indent="0">
              <a:buNone/>
              <a:defRPr sz="893"/>
            </a:lvl7pPr>
            <a:lvl8pPr marL="2858917" indent="0">
              <a:buNone/>
              <a:defRPr sz="893"/>
            </a:lvl8pPr>
            <a:lvl9pPr marL="3267334" indent="0">
              <a:buNone/>
              <a:defRPr sz="89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845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66931" y="326162"/>
            <a:ext cx="9621501" cy="1184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6931" y="1630807"/>
            <a:ext cx="9621501" cy="38869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6931" y="5678046"/>
            <a:ext cx="2509957" cy="326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C891B-0D41-46C9-938E-FF446D078137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95214" y="5678046"/>
            <a:ext cx="3764935" cy="326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78475" y="5678046"/>
            <a:ext cx="2509957" cy="326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E8EDE-78B8-485A-B27E-0E78544CFB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29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16834" rtl="0" eaLnBrk="1" latinLnBrk="0" hangingPunct="1">
        <a:lnSpc>
          <a:spcPct val="90000"/>
        </a:lnSpc>
        <a:spcBef>
          <a:spcPct val="0"/>
        </a:spcBef>
        <a:buNone/>
        <a:defRPr sz="393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4208" indent="-204208" algn="l" defTabSz="816834" rtl="0" eaLnBrk="1" latinLnBrk="0" hangingPunct="1">
        <a:lnSpc>
          <a:spcPct val="90000"/>
        </a:lnSpc>
        <a:spcBef>
          <a:spcPts val="893"/>
        </a:spcBef>
        <a:buFont typeface="Arial" panose="020B0604020202020204" pitchFamily="34" charset="0"/>
        <a:buChar char="•"/>
        <a:defRPr sz="2501" kern="1200">
          <a:solidFill>
            <a:schemeClr val="tx1"/>
          </a:solidFill>
          <a:latin typeface="+mn-lt"/>
          <a:ea typeface="+mn-ea"/>
          <a:cs typeface="+mn-cs"/>
        </a:defRPr>
      </a:lvl1pPr>
      <a:lvl2pPr marL="612625" indent="-204208" algn="l" defTabSz="816834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2144" kern="1200">
          <a:solidFill>
            <a:schemeClr val="tx1"/>
          </a:solidFill>
          <a:latin typeface="+mn-lt"/>
          <a:ea typeface="+mn-ea"/>
          <a:cs typeface="+mn-cs"/>
        </a:defRPr>
      </a:lvl2pPr>
      <a:lvl3pPr marL="1021042" indent="-204208" algn="l" defTabSz="816834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787" kern="1200">
          <a:solidFill>
            <a:schemeClr val="tx1"/>
          </a:solidFill>
          <a:latin typeface="+mn-lt"/>
          <a:ea typeface="+mn-ea"/>
          <a:cs typeface="+mn-cs"/>
        </a:defRPr>
      </a:lvl3pPr>
      <a:lvl4pPr marL="1429459" indent="-204208" algn="l" defTabSz="816834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8" kern="1200">
          <a:solidFill>
            <a:schemeClr val="tx1"/>
          </a:solidFill>
          <a:latin typeface="+mn-lt"/>
          <a:ea typeface="+mn-ea"/>
          <a:cs typeface="+mn-cs"/>
        </a:defRPr>
      </a:lvl4pPr>
      <a:lvl5pPr marL="1837875" indent="-204208" algn="l" defTabSz="816834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8" kern="1200">
          <a:solidFill>
            <a:schemeClr val="tx1"/>
          </a:solidFill>
          <a:latin typeface="+mn-lt"/>
          <a:ea typeface="+mn-ea"/>
          <a:cs typeface="+mn-cs"/>
        </a:defRPr>
      </a:lvl5pPr>
      <a:lvl6pPr marL="2246292" indent="-204208" algn="l" defTabSz="816834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8" kern="1200">
          <a:solidFill>
            <a:schemeClr val="tx1"/>
          </a:solidFill>
          <a:latin typeface="+mn-lt"/>
          <a:ea typeface="+mn-ea"/>
          <a:cs typeface="+mn-cs"/>
        </a:defRPr>
      </a:lvl6pPr>
      <a:lvl7pPr marL="2654709" indent="-204208" algn="l" defTabSz="816834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8" kern="1200">
          <a:solidFill>
            <a:schemeClr val="tx1"/>
          </a:solidFill>
          <a:latin typeface="+mn-lt"/>
          <a:ea typeface="+mn-ea"/>
          <a:cs typeface="+mn-cs"/>
        </a:defRPr>
      </a:lvl7pPr>
      <a:lvl8pPr marL="3063126" indent="-204208" algn="l" defTabSz="816834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8" kern="1200">
          <a:solidFill>
            <a:schemeClr val="tx1"/>
          </a:solidFill>
          <a:latin typeface="+mn-lt"/>
          <a:ea typeface="+mn-ea"/>
          <a:cs typeface="+mn-cs"/>
        </a:defRPr>
      </a:lvl8pPr>
      <a:lvl9pPr marL="3471542" indent="-204208" algn="l" defTabSz="816834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6834" rtl="0" eaLnBrk="1" latinLnBrk="0" hangingPunct="1">
        <a:defRPr sz="1608" kern="1200">
          <a:solidFill>
            <a:schemeClr val="tx1"/>
          </a:solidFill>
          <a:latin typeface="+mn-lt"/>
          <a:ea typeface="+mn-ea"/>
          <a:cs typeface="+mn-cs"/>
        </a:defRPr>
      </a:lvl1pPr>
      <a:lvl2pPr marL="408417" algn="l" defTabSz="816834" rtl="0" eaLnBrk="1" latinLnBrk="0" hangingPunct="1">
        <a:defRPr sz="1608" kern="1200">
          <a:solidFill>
            <a:schemeClr val="tx1"/>
          </a:solidFill>
          <a:latin typeface="+mn-lt"/>
          <a:ea typeface="+mn-ea"/>
          <a:cs typeface="+mn-cs"/>
        </a:defRPr>
      </a:lvl2pPr>
      <a:lvl3pPr marL="816834" algn="l" defTabSz="816834" rtl="0" eaLnBrk="1" latinLnBrk="0" hangingPunct="1">
        <a:defRPr sz="1608" kern="1200">
          <a:solidFill>
            <a:schemeClr val="tx1"/>
          </a:solidFill>
          <a:latin typeface="+mn-lt"/>
          <a:ea typeface="+mn-ea"/>
          <a:cs typeface="+mn-cs"/>
        </a:defRPr>
      </a:lvl3pPr>
      <a:lvl4pPr marL="1225250" algn="l" defTabSz="816834" rtl="0" eaLnBrk="1" latinLnBrk="0" hangingPunct="1">
        <a:defRPr sz="1608" kern="1200">
          <a:solidFill>
            <a:schemeClr val="tx1"/>
          </a:solidFill>
          <a:latin typeface="+mn-lt"/>
          <a:ea typeface="+mn-ea"/>
          <a:cs typeface="+mn-cs"/>
        </a:defRPr>
      </a:lvl4pPr>
      <a:lvl5pPr marL="1633667" algn="l" defTabSz="816834" rtl="0" eaLnBrk="1" latinLnBrk="0" hangingPunct="1">
        <a:defRPr sz="1608" kern="1200">
          <a:solidFill>
            <a:schemeClr val="tx1"/>
          </a:solidFill>
          <a:latin typeface="+mn-lt"/>
          <a:ea typeface="+mn-ea"/>
          <a:cs typeface="+mn-cs"/>
        </a:defRPr>
      </a:lvl5pPr>
      <a:lvl6pPr marL="2042084" algn="l" defTabSz="816834" rtl="0" eaLnBrk="1" latinLnBrk="0" hangingPunct="1">
        <a:defRPr sz="1608" kern="1200">
          <a:solidFill>
            <a:schemeClr val="tx1"/>
          </a:solidFill>
          <a:latin typeface="+mn-lt"/>
          <a:ea typeface="+mn-ea"/>
          <a:cs typeface="+mn-cs"/>
        </a:defRPr>
      </a:lvl6pPr>
      <a:lvl7pPr marL="2450501" algn="l" defTabSz="816834" rtl="0" eaLnBrk="1" latinLnBrk="0" hangingPunct="1">
        <a:defRPr sz="1608" kern="1200">
          <a:solidFill>
            <a:schemeClr val="tx1"/>
          </a:solidFill>
          <a:latin typeface="+mn-lt"/>
          <a:ea typeface="+mn-ea"/>
          <a:cs typeface="+mn-cs"/>
        </a:defRPr>
      </a:lvl7pPr>
      <a:lvl8pPr marL="2858917" algn="l" defTabSz="816834" rtl="0" eaLnBrk="1" latinLnBrk="0" hangingPunct="1">
        <a:defRPr sz="1608" kern="1200">
          <a:solidFill>
            <a:schemeClr val="tx1"/>
          </a:solidFill>
          <a:latin typeface="+mn-lt"/>
          <a:ea typeface="+mn-ea"/>
          <a:cs typeface="+mn-cs"/>
        </a:defRPr>
      </a:lvl8pPr>
      <a:lvl9pPr marL="3267334" algn="l" defTabSz="816834" rtl="0" eaLnBrk="1" latinLnBrk="0" hangingPunct="1">
        <a:defRPr sz="16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136" y="287702"/>
            <a:ext cx="5257800" cy="512445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03498" y="287702"/>
            <a:ext cx="5257800" cy="512445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53150" y="5602026"/>
            <a:ext cx="1100815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Yu Mincho" panose="02020400000000000000" pitchFamily="18" charset="-128"/>
              </a:rPr>
              <a:t>Figure S3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Yu Mincho" panose="02020400000000000000" pitchFamily="18" charset="-128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Kaplan-Meier curves for progression-free survival, according to the levels of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ADGRL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 (A) and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ADGRL2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PGothic" panose="020B0600070205080204" pitchFamily="34" charset="-128"/>
              </a:rPr>
              <a:t> (B) expression in patients with Ta or T1 bladder cancer who did not undergo cystectomy.</a:t>
            </a:r>
            <a:endParaRPr lang="en-US" sz="1200" dirty="0"/>
          </a:p>
        </p:txBody>
      </p:sp>
      <p:sp>
        <p:nvSpPr>
          <p:cNvPr id="6" name="Rectangle 5"/>
          <p:cNvSpPr/>
          <p:nvPr/>
        </p:nvSpPr>
        <p:spPr>
          <a:xfrm>
            <a:off x="53147" y="97834"/>
            <a:ext cx="40748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A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5701375" y="97834"/>
            <a:ext cx="40748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B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3080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1</TotalTime>
  <Words>40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MS PGothic</vt:lpstr>
      <vt:lpstr>Yu Mincho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yamoto, Hiroshi</dc:creator>
  <cp:lastModifiedBy>Miyamoto, Hiroshi</cp:lastModifiedBy>
  <cp:revision>13</cp:revision>
  <dcterms:created xsi:type="dcterms:W3CDTF">2026-05-22T12:55:11Z</dcterms:created>
  <dcterms:modified xsi:type="dcterms:W3CDTF">2026-07-07T12:01:55Z</dcterms:modified>
</cp:coreProperties>
</file>